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017000" cy="1259967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17" userDrawn="1">
          <p15:clr>
            <a:srgbClr val="A4A3A4"/>
          </p15:clr>
        </p15:guide>
        <p15:guide id="2" pos="28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1256" y="-212"/>
      </p:cViewPr>
      <p:guideLst>
        <p:guide orient="horz" pos="3917"/>
        <p:guide pos="2862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886857" y="1680138"/>
            <a:ext cx="7249325" cy="4722907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5915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886857" y="6541955"/>
            <a:ext cx="7249325" cy="2705419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365" spc="200"/>
            </a:lvl1pPr>
            <a:lvl2pPr marL="450850" indent="0" algn="ctr">
              <a:buNone/>
              <a:defRPr sz="1970"/>
            </a:lvl2pPr>
            <a:lvl3pPr marL="901700" indent="0" algn="ctr">
              <a:buNone/>
              <a:defRPr sz="1780"/>
            </a:lvl3pPr>
            <a:lvl4pPr marL="1352550" indent="0" algn="ctr">
              <a:buNone/>
              <a:defRPr sz="1580"/>
            </a:lvl4pPr>
            <a:lvl5pPr marL="1804035" indent="0" algn="ctr">
              <a:buNone/>
              <a:defRPr sz="1580"/>
            </a:lvl5pPr>
            <a:lvl6pPr marL="2254250" indent="0" algn="ctr">
              <a:buNone/>
              <a:defRPr sz="1580"/>
            </a:lvl6pPr>
            <a:lvl7pPr marL="2705100" indent="0" algn="ctr">
              <a:buNone/>
              <a:defRPr sz="1580"/>
            </a:lvl7pPr>
            <a:lvl8pPr marL="3157220" indent="0" algn="ctr">
              <a:buNone/>
              <a:defRPr sz="1580"/>
            </a:lvl8pPr>
            <a:lvl9pPr marL="3607435" indent="0" algn="ctr">
              <a:buNone/>
              <a:defRPr sz="158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450087" y="1422164"/>
            <a:ext cx="8117540" cy="10074212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886857" y="4564153"/>
            <a:ext cx="7249325" cy="1871964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5915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886857" y="6541955"/>
            <a:ext cx="7249325" cy="866528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365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0087" y="1117887"/>
            <a:ext cx="8114877" cy="129648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450087" y="2738493"/>
            <a:ext cx="8114877" cy="874465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472769" y="7071132"/>
            <a:ext cx="5747261" cy="1408935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34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472769" y="8480067"/>
            <a:ext cx="5747261" cy="1594145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78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0850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2pPr>
            <a:lvl3pPr marL="901700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3pPr>
            <a:lvl4pPr marL="1352550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4pPr>
            <a:lvl5pPr marL="1804035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5pPr>
            <a:lvl6pPr marL="2254250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6pPr>
            <a:lvl7pPr marL="2705100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7pPr>
            <a:lvl8pPr marL="3157220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8pPr>
            <a:lvl9pPr marL="3607435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0087" y="1117887"/>
            <a:ext cx="8114877" cy="129648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450087" y="2758336"/>
            <a:ext cx="3829732" cy="872481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743222" y="2758336"/>
            <a:ext cx="3829732" cy="872481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0087" y="1117887"/>
            <a:ext cx="8114877" cy="129648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450087" y="2626041"/>
            <a:ext cx="3952241" cy="701161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97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0850" indent="0">
              <a:buNone/>
              <a:defRPr sz="1970" b="1"/>
            </a:lvl2pPr>
            <a:lvl3pPr marL="901700" indent="0">
              <a:buNone/>
              <a:defRPr sz="1780" b="1"/>
            </a:lvl3pPr>
            <a:lvl4pPr marL="1352550" indent="0">
              <a:buNone/>
              <a:defRPr sz="1580" b="1"/>
            </a:lvl4pPr>
            <a:lvl5pPr marL="1804035" indent="0">
              <a:buNone/>
              <a:defRPr sz="1580" b="1"/>
            </a:lvl5pPr>
            <a:lvl6pPr marL="2254250" indent="0">
              <a:buNone/>
              <a:defRPr sz="1580" b="1"/>
            </a:lvl6pPr>
            <a:lvl7pPr marL="2705100" indent="0">
              <a:buNone/>
              <a:defRPr sz="1580" b="1"/>
            </a:lvl7pPr>
            <a:lvl8pPr marL="3157220" indent="0">
              <a:buNone/>
              <a:defRPr sz="1580" b="1"/>
            </a:lvl8pPr>
            <a:lvl9pPr marL="3607435" indent="0">
              <a:buNone/>
              <a:defRPr sz="158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50087" y="3406580"/>
            <a:ext cx="3952241" cy="8076568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4613131" y="2612315"/>
            <a:ext cx="3952241" cy="701161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97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0850" indent="0">
              <a:buNone/>
              <a:defRPr sz="1970" b="1"/>
            </a:lvl2pPr>
            <a:lvl3pPr marL="901700" indent="0">
              <a:buNone/>
              <a:defRPr sz="1780" b="1"/>
            </a:lvl3pPr>
            <a:lvl4pPr marL="1352550" indent="0">
              <a:buNone/>
              <a:defRPr sz="1580" b="1"/>
            </a:lvl4pPr>
            <a:lvl5pPr marL="1804035" indent="0">
              <a:buNone/>
              <a:defRPr sz="1580" b="1"/>
            </a:lvl5pPr>
            <a:lvl6pPr marL="2254250" indent="0">
              <a:buNone/>
              <a:defRPr sz="1580" b="1"/>
            </a:lvl6pPr>
            <a:lvl7pPr marL="2705100" indent="0">
              <a:buNone/>
              <a:defRPr sz="1580" b="1"/>
            </a:lvl7pPr>
            <a:lvl8pPr marL="3157220" indent="0">
              <a:buNone/>
              <a:defRPr sz="1580" b="1"/>
            </a:lvl8pPr>
            <a:lvl9pPr marL="3607435" indent="0">
              <a:buNone/>
              <a:defRPr sz="158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4613131" y="3406580"/>
            <a:ext cx="3952241" cy="8076568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0087" y="1117887"/>
            <a:ext cx="8114877" cy="129648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450087" y="2857558"/>
            <a:ext cx="3871366" cy="846683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58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4697947" y="2857558"/>
            <a:ext cx="3867017" cy="846683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58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7571577" y="1680138"/>
            <a:ext cx="772338" cy="9240758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76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76461" y="1680138"/>
            <a:ext cx="6783259" cy="9240758"/>
          </a:xfrm>
        </p:spPr>
        <p:txBody>
          <a:bodyPr vert="eaVert" lIns="46800" tIns="46800" rIns="46800" bIns="46800"/>
          <a:lstStyle>
            <a:lvl1pPr marL="226060" indent="-226060">
              <a:spcAft>
                <a:spcPts val="1000"/>
              </a:spcAft>
              <a:defRPr spc="300"/>
            </a:lvl1pPr>
            <a:lvl2pPr marL="676910" indent="-226060">
              <a:defRPr spc="300"/>
            </a:lvl2pPr>
            <a:lvl3pPr marL="1128395" indent="-226060">
              <a:defRPr spc="300"/>
            </a:lvl3pPr>
            <a:lvl4pPr marL="1578610" indent="-226060">
              <a:defRPr spc="300"/>
            </a:lvl4pPr>
            <a:lvl5pPr marL="2029460" indent="-22606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450087" y="1117887"/>
            <a:ext cx="8114877" cy="1296484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450087" y="2738493"/>
            <a:ext cx="8114877" cy="874465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452750" y="11602214"/>
            <a:ext cx="1997426" cy="5820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9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3044965" y="11602214"/>
            <a:ext cx="2929558" cy="5820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9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6567538" y="11602214"/>
            <a:ext cx="1997426" cy="5820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9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01700" rtl="0" eaLnBrk="1" fontAlgn="auto" latinLnBrk="0" hangingPunct="1">
        <a:lnSpc>
          <a:spcPct val="100000"/>
        </a:lnSpc>
        <a:spcBef>
          <a:spcPct val="0"/>
        </a:spcBef>
        <a:buNone/>
        <a:defRPr sz="355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6060" indent="-226060" algn="l" defTabSz="9017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78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76910" indent="-226060" algn="l" defTabSz="9017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587500" algn="l"/>
          <a:tab pos="1587500" algn="l"/>
          <a:tab pos="1587500" algn="l"/>
          <a:tab pos="1587500" algn="l"/>
        </a:tabLst>
        <a:defRPr sz="158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28395" indent="-226060" algn="l" defTabSz="9017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58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578610" indent="-226060" algn="l" defTabSz="9017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38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29460" indent="-226060" algn="l" defTabSz="9017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38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480945" indent="-226060" algn="l" defTabSz="901700" rtl="0" eaLnBrk="1" latinLnBrk="0" hangingPunct="1">
        <a:lnSpc>
          <a:spcPct val="90000"/>
        </a:lnSpc>
        <a:spcBef>
          <a:spcPct val="99000"/>
        </a:spcBef>
        <a:buFont typeface="Arial" panose="020B0604020202020204" pitchFamily="34" charset="0"/>
        <a:buChar char="•"/>
        <a:defRPr sz="1780" kern="1200">
          <a:solidFill>
            <a:schemeClr val="tx1"/>
          </a:solidFill>
          <a:latin typeface="+mn-lt"/>
          <a:ea typeface="+mn-ea"/>
          <a:cs typeface="+mn-cs"/>
        </a:defRPr>
      </a:lvl6pPr>
      <a:lvl7pPr marL="2931160" indent="-226060" algn="l" defTabSz="901700" rtl="0" eaLnBrk="1" latinLnBrk="0" hangingPunct="1">
        <a:lnSpc>
          <a:spcPct val="90000"/>
        </a:lnSpc>
        <a:spcBef>
          <a:spcPct val="99000"/>
        </a:spcBef>
        <a:buFont typeface="Arial" panose="020B0604020202020204" pitchFamily="34" charset="0"/>
        <a:buChar char="•"/>
        <a:defRPr sz="1780" kern="1200">
          <a:solidFill>
            <a:schemeClr val="tx1"/>
          </a:solidFill>
          <a:latin typeface="+mn-lt"/>
          <a:ea typeface="+mn-ea"/>
          <a:cs typeface="+mn-cs"/>
        </a:defRPr>
      </a:lvl7pPr>
      <a:lvl8pPr marL="3382010" indent="-226060" algn="l" defTabSz="901700" rtl="0" eaLnBrk="1" latinLnBrk="0" hangingPunct="1">
        <a:lnSpc>
          <a:spcPct val="90000"/>
        </a:lnSpc>
        <a:spcBef>
          <a:spcPct val="99000"/>
        </a:spcBef>
        <a:buFont typeface="Arial" panose="020B0604020202020204" pitchFamily="34" charset="0"/>
        <a:buChar char="•"/>
        <a:defRPr sz="1780" kern="1200">
          <a:solidFill>
            <a:schemeClr val="tx1"/>
          </a:solidFill>
          <a:latin typeface="+mn-lt"/>
          <a:ea typeface="+mn-ea"/>
          <a:cs typeface="+mn-cs"/>
        </a:defRPr>
      </a:lvl8pPr>
      <a:lvl9pPr marL="3833495" indent="-226060" algn="l" defTabSz="901700" rtl="0" eaLnBrk="1" latinLnBrk="0" hangingPunct="1">
        <a:lnSpc>
          <a:spcPct val="90000"/>
        </a:lnSpc>
        <a:spcBef>
          <a:spcPct val="99000"/>
        </a:spcBef>
        <a:buFont typeface="Arial" panose="020B0604020202020204" pitchFamily="34" charset="0"/>
        <a:buChar char="•"/>
        <a:defRPr sz="17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1pPr>
      <a:lvl2pPr marL="45085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2pPr>
      <a:lvl3pPr marL="90170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3pPr>
      <a:lvl4pPr marL="135255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4pPr>
      <a:lvl5pPr marL="1804035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5pPr>
      <a:lvl6pPr marL="225425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6pPr>
      <a:lvl7pPr marL="270510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7pPr>
      <a:lvl8pPr marL="3157220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8pPr>
      <a:lvl9pPr marL="3607435" algn="l" defTabSz="901700" rtl="0" eaLnBrk="1" latinLnBrk="0" hangingPunct="1">
        <a:defRPr sz="17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7.xml"/><Relationship Id="rId8" Type="http://schemas.openxmlformats.org/officeDocument/2006/relationships/image" Target="../media/image4.png"/><Relationship Id="rId7" Type="http://schemas.openxmlformats.org/officeDocument/2006/relationships/tags" Target="../tags/tag66.xml"/><Relationship Id="rId6" Type="http://schemas.openxmlformats.org/officeDocument/2006/relationships/image" Target="../media/image3.jpeg"/><Relationship Id="rId5" Type="http://schemas.openxmlformats.org/officeDocument/2006/relationships/tags" Target="../tags/tag65.xml"/><Relationship Id="rId4" Type="http://schemas.openxmlformats.org/officeDocument/2006/relationships/image" Target="../media/image2.jpeg"/><Relationship Id="rId33" Type="http://schemas.openxmlformats.org/officeDocument/2006/relationships/slideLayout" Target="../slideLayouts/slideLayout1.xml"/><Relationship Id="rId32" Type="http://schemas.openxmlformats.org/officeDocument/2006/relationships/tags" Target="../tags/tag79.xml"/><Relationship Id="rId31" Type="http://schemas.openxmlformats.org/officeDocument/2006/relationships/tags" Target="../tags/tag78.xml"/><Relationship Id="rId30" Type="http://schemas.openxmlformats.org/officeDocument/2006/relationships/tags" Target="../tags/tag77.xml"/><Relationship Id="rId3" Type="http://schemas.openxmlformats.org/officeDocument/2006/relationships/tags" Target="../tags/tag64.xml"/><Relationship Id="rId29" Type="http://schemas.openxmlformats.org/officeDocument/2006/relationships/tags" Target="../tags/tag76.xml"/><Relationship Id="rId28" Type="http://schemas.openxmlformats.org/officeDocument/2006/relationships/tags" Target="../tags/tag75.xml"/><Relationship Id="rId27" Type="http://schemas.openxmlformats.org/officeDocument/2006/relationships/tags" Target="../tags/tag74.xml"/><Relationship Id="rId26" Type="http://schemas.openxmlformats.org/officeDocument/2006/relationships/image" Target="../media/image15.jpeg"/><Relationship Id="rId25" Type="http://schemas.openxmlformats.org/officeDocument/2006/relationships/image" Target="../media/image14.jpeg"/><Relationship Id="rId24" Type="http://schemas.openxmlformats.org/officeDocument/2006/relationships/image" Target="../media/image13.png"/><Relationship Id="rId23" Type="http://schemas.openxmlformats.org/officeDocument/2006/relationships/image" Target="../media/image12.png"/><Relationship Id="rId22" Type="http://schemas.openxmlformats.org/officeDocument/2006/relationships/image" Target="../media/image11.jpeg"/><Relationship Id="rId21" Type="http://schemas.openxmlformats.org/officeDocument/2006/relationships/image" Target="../media/image10.jpeg"/><Relationship Id="rId20" Type="http://schemas.openxmlformats.org/officeDocument/2006/relationships/image" Target="../media/image9.png"/><Relationship Id="rId2" Type="http://schemas.openxmlformats.org/officeDocument/2006/relationships/image" Target="../media/image1.jpeg"/><Relationship Id="rId19" Type="http://schemas.openxmlformats.org/officeDocument/2006/relationships/image" Target="../media/image8.png"/><Relationship Id="rId18" Type="http://schemas.openxmlformats.org/officeDocument/2006/relationships/image" Target="../media/image7.png"/><Relationship Id="rId17" Type="http://schemas.openxmlformats.org/officeDocument/2006/relationships/tags" Target="../tags/tag73.xml"/><Relationship Id="rId16" Type="http://schemas.openxmlformats.org/officeDocument/2006/relationships/tags" Target="../tags/tag72.xml"/><Relationship Id="rId15" Type="http://schemas.openxmlformats.org/officeDocument/2006/relationships/tags" Target="../tags/tag71.xml"/><Relationship Id="rId14" Type="http://schemas.openxmlformats.org/officeDocument/2006/relationships/tags" Target="../tags/tag70.xml"/><Relationship Id="rId13" Type="http://schemas.openxmlformats.org/officeDocument/2006/relationships/tags" Target="../tags/tag69.xml"/><Relationship Id="rId12" Type="http://schemas.openxmlformats.org/officeDocument/2006/relationships/image" Target="../media/image6.jpeg"/><Relationship Id="rId11" Type="http://schemas.openxmlformats.org/officeDocument/2006/relationships/tags" Target="../tags/tag68.xml"/><Relationship Id="rId10" Type="http://schemas.openxmlformats.org/officeDocument/2006/relationships/image" Target="../media/image5.jpeg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8" descr="volcano plot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336723" y="253988"/>
            <a:ext cx="2736715" cy="1952054"/>
          </a:xfrm>
          <a:prstGeom prst="rect">
            <a:avLst/>
          </a:prstGeom>
        </p:spPr>
      </p:pic>
      <p:pic>
        <p:nvPicPr>
          <p:cNvPr id="4" name="图片 4" descr="volcano plot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3184912" y="241602"/>
            <a:ext cx="2818463" cy="1963201"/>
          </a:xfrm>
          <a:prstGeom prst="rect">
            <a:avLst/>
          </a:prstGeom>
        </p:spPr>
      </p:pic>
      <p:pic>
        <p:nvPicPr>
          <p:cNvPr id="5" name="图片 1" descr="volcano plot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5904874" y="241602"/>
            <a:ext cx="2827989" cy="1915103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rcRect r="26926"/>
          <a:stretch>
            <a:fillRect/>
          </a:stretch>
        </p:blipFill>
        <p:spPr>
          <a:xfrm>
            <a:off x="2805312" y="5244604"/>
            <a:ext cx="2514384" cy="2151470"/>
          </a:xfrm>
          <a:prstGeom prst="rect">
            <a:avLst/>
          </a:prstGeom>
        </p:spPr>
      </p:pic>
      <p:pic>
        <p:nvPicPr>
          <p:cNvPr id="10" name="图片 9" descr="OPLS-DA permutation plot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5569345" y="5224326"/>
            <a:ext cx="3332158" cy="2125581"/>
          </a:xfrm>
          <a:prstGeom prst="rect">
            <a:avLst/>
          </a:prstGeom>
        </p:spPr>
      </p:pic>
      <p:pic>
        <p:nvPicPr>
          <p:cNvPr id="14" name="图片 13" descr="OPLS-DA permutation plot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rcRect r="26878"/>
          <a:stretch>
            <a:fillRect/>
          </a:stretch>
        </p:blipFill>
        <p:spPr>
          <a:xfrm>
            <a:off x="-11468" y="5230188"/>
            <a:ext cx="2511287" cy="2164476"/>
          </a:xfrm>
          <a:prstGeom prst="rect">
            <a:avLst/>
          </a:prstGeom>
        </p:spPr>
      </p:pic>
      <p:sp>
        <p:nvSpPr>
          <p:cNvPr id="15" name="文本框 14"/>
          <p:cNvSpPr txBox="1"/>
          <p:nvPr>
            <p:custDataLst>
              <p:tags r:id="rId13"/>
            </p:custDataLst>
          </p:nvPr>
        </p:nvSpPr>
        <p:spPr>
          <a:xfrm>
            <a:off x="-10788" y="2271719"/>
            <a:ext cx="3137027" cy="269240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pPr algn="ctr"/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re-treatment VS Post-treatment</a:t>
            </a:r>
            <a:endParaRPr lang="en-US" altLang="zh-CN" sz="1155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14"/>
            </p:custDataLst>
          </p:nvPr>
        </p:nvSpPr>
        <p:spPr>
          <a:xfrm>
            <a:off x="5607" y="38400"/>
            <a:ext cx="2972670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zh-CN" altLang="en-US" sz="135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15"/>
            </p:custDataLst>
          </p:nvPr>
        </p:nvSpPr>
        <p:spPr>
          <a:xfrm>
            <a:off x="128479" y="2387204"/>
            <a:ext cx="2972670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 sz="135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16"/>
            </p:custDataLst>
          </p:nvPr>
        </p:nvSpPr>
        <p:spPr>
          <a:xfrm>
            <a:off x="174953" y="6219203"/>
            <a:ext cx="2972670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 sz="135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17"/>
            </p:custDataLst>
          </p:nvPr>
        </p:nvSpPr>
        <p:spPr>
          <a:xfrm>
            <a:off x="38088" y="7759315"/>
            <a:ext cx="2972670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 sz="135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999661" y="2248977"/>
            <a:ext cx="2606877" cy="28450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re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8712" y="2795785"/>
            <a:ext cx="2833370" cy="177165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853242" y="2757685"/>
            <a:ext cx="2865755" cy="179197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922082" y="2783085"/>
            <a:ext cx="2855595" cy="1784985"/>
          </a:xfrm>
          <a:prstGeom prst="rect">
            <a:avLst/>
          </a:prstGeom>
        </p:spPr>
      </p:pic>
      <p:sp>
        <p:nvSpPr>
          <p:cNvPr id="36" name="文本框 35"/>
          <p:cNvSpPr txBox="1"/>
          <p:nvPr/>
        </p:nvSpPr>
        <p:spPr>
          <a:xfrm>
            <a:off x="5780089" y="2255790"/>
            <a:ext cx="2683510" cy="4248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ost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7" name="图片 36" descr="KEGG DA Score plot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2765" y="8023862"/>
            <a:ext cx="3037205" cy="1708150"/>
          </a:xfrm>
          <a:prstGeom prst="rect">
            <a:avLst/>
          </a:prstGeom>
        </p:spPr>
      </p:pic>
      <p:pic>
        <p:nvPicPr>
          <p:cNvPr id="38" name="图片 37" descr="KEGG heatmap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264022" y="8101993"/>
            <a:ext cx="4509770" cy="107061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-18085" y="9606582"/>
            <a:ext cx="3556635" cy="1466850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315441" y="9431885"/>
            <a:ext cx="4531125" cy="1201119"/>
          </a:xfrm>
          <a:prstGeom prst="rect">
            <a:avLst/>
          </a:prstGeom>
        </p:spPr>
      </p:pic>
      <p:pic>
        <p:nvPicPr>
          <p:cNvPr id="41" name="图片 40" descr="KEGG DA Score plot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855" y="10900830"/>
            <a:ext cx="3434080" cy="1416685"/>
          </a:xfrm>
          <a:prstGeom prst="rect">
            <a:avLst/>
          </a:prstGeom>
        </p:spPr>
      </p:pic>
      <p:pic>
        <p:nvPicPr>
          <p:cNvPr id="42" name="图片 41" descr="KEGG heatmap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315441" y="10913195"/>
            <a:ext cx="4526583" cy="1201118"/>
          </a:xfrm>
          <a:prstGeom prst="rect">
            <a:avLst/>
          </a:prstGeom>
        </p:spPr>
      </p:pic>
      <p:sp>
        <p:nvSpPr>
          <p:cNvPr id="32" name="文本框 31"/>
          <p:cNvSpPr txBox="1"/>
          <p:nvPr>
            <p:custDataLst>
              <p:tags r:id="rId27"/>
            </p:custDataLst>
          </p:nvPr>
        </p:nvSpPr>
        <p:spPr>
          <a:xfrm>
            <a:off x="-135573" y="4603960"/>
            <a:ext cx="3137027" cy="269240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pPr algn="ctr"/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re-treatment VS Post-treatment</a:t>
            </a:r>
            <a:endParaRPr lang="en-US" altLang="zh-CN" sz="1155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805312" y="4636258"/>
            <a:ext cx="2972365" cy="29488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re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780089" y="4588031"/>
            <a:ext cx="2683510" cy="4248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ost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28"/>
            </p:custDataLst>
          </p:nvPr>
        </p:nvSpPr>
        <p:spPr>
          <a:xfrm>
            <a:off x="-51235" y="7416687"/>
            <a:ext cx="3137027" cy="269240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pPr algn="ctr"/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re-treatment VS Post-treatment</a:t>
            </a:r>
            <a:endParaRPr lang="en-US" altLang="zh-CN" sz="1155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741688" y="7421380"/>
            <a:ext cx="2972365" cy="29488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re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5864427" y="7400758"/>
            <a:ext cx="2683510" cy="4248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ost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29"/>
            </p:custDataLst>
          </p:nvPr>
        </p:nvSpPr>
        <p:spPr>
          <a:xfrm>
            <a:off x="22487" y="4969997"/>
            <a:ext cx="2972670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 sz="135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30"/>
            </p:custDataLst>
          </p:nvPr>
        </p:nvSpPr>
        <p:spPr>
          <a:xfrm>
            <a:off x="2489161" y="9178078"/>
            <a:ext cx="3137027" cy="269240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pPr algn="ctr"/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155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re-treatment VS Post-treatment</a:t>
            </a:r>
            <a:endParaRPr lang="en-US" altLang="zh-CN" sz="1155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2651070" y="10542795"/>
            <a:ext cx="2972365" cy="29488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re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2858458" y="12136494"/>
            <a:ext cx="2683510" cy="4248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Non-responders VS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onders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Post-treatment) 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31"/>
            </p:custDataLst>
          </p:nvPr>
        </p:nvSpPr>
        <p:spPr>
          <a:xfrm>
            <a:off x="4077256" y="7762090"/>
            <a:ext cx="2972670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Times New Roman" panose="02020603050405020304" charset="0"/>
                <a:cs typeface="Times New Roman" panose="02020603050405020304" charset="0"/>
              </a:rPr>
              <a:t>(E)</a:t>
            </a:r>
            <a:endParaRPr lang="en-US" altLang="zh-CN" sz="135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3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64.xml><?xml version="1.0" encoding="utf-8"?>
<p:tagLst xmlns:p="http://schemas.openxmlformats.org/presentationml/2006/main">
  <p:tag name="KSO_WM_DIAGRAM_VIRTUALLY_FRAME" val="{&quot;height&quot;:789.7385039370079,&quot;left&quot;:-4.7,&quot;top&quot;:0.08023622047244094,&quot;width&quot;:727.4714356126149}"/>
</p:tagLst>
</file>

<file path=ppt/tags/tag65.xml><?xml version="1.0" encoding="utf-8"?>
<p:tagLst xmlns:p="http://schemas.openxmlformats.org/presentationml/2006/main">
  <p:tag name="KSO_WM_DIAGRAM_VIRTUALLY_FRAME" val="{&quot;height&quot;:789.7385039370079,&quot;left&quot;:-4.7,&quot;top&quot;:0.08023622047244094,&quot;width&quot;:727.4714356126149}"/>
</p:tagLst>
</file>

<file path=ppt/tags/tag66.xml><?xml version="1.0" encoding="utf-8"?>
<p:tagLst xmlns:p="http://schemas.openxmlformats.org/presentationml/2006/main">
  <p:tag name="KSO_WM_DIAGRAM_VIRTUALLY_FRAME" val="{&quot;height&quot;:789.7385039370079,&quot;left&quot;:-4.7,&quot;top&quot;:0.08023622047244094,&quot;width&quot;:727.4714356126149}"/>
</p:tagLst>
</file>

<file path=ppt/tags/tag67.xml><?xml version="1.0" encoding="utf-8"?>
<p:tagLst xmlns:p="http://schemas.openxmlformats.org/presentationml/2006/main">
  <p:tag name="KSO_WM_DIAGRAM_VIRTUALLY_FRAME" val="{&quot;height&quot;:789.7385039370079,&quot;left&quot;:-4.7,&quot;top&quot;:0.08023622047244094,&quot;width&quot;:727.4714356126149}"/>
</p:tagLst>
</file>

<file path=ppt/tags/tag68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69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1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2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3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4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5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6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7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8.xml><?xml version="1.0" encoding="utf-8"?>
<p:tagLst xmlns:p="http://schemas.openxmlformats.org/presentationml/2006/main">
  <p:tag name="KSO_WM_DIAGRAM_VIRTUALLY_FRAME" val="{&quot;height&quot;:888.9665247216917,&quot;left&quot;:-4.700190044935221,&quot;top&quot;:0.08023622047244094,&quot;width&quot;:727.4716256575501}"/>
</p:tagLst>
</file>

<file path=ppt/tags/tag79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0</Words>
  <Application>WPS 演示</Application>
  <PresentationFormat>自定义</PresentationFormat>
  <Paragraphs>4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Jing Zhang</cp:lastModifiedBy>
  <cp:revision>171</cp:revision>
  <dcterms:created xsi:type="dcterms:W3CDTF">2019-06-19T02:08:00Z</dcterms:created>
  <dcterms:modified xsi:type="dcterms:W3CDTF">2026-03-02T13:15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1792E51F652E4C2B89A6397C9B4BE2D3_13</vt:lpwstr>
  </property>
</Properties>
</file>